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39" d="100"/>
          <a:sy n="139" d="100"/>
        </p:scale>
        <p:origin x="-1232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890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538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998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80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103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523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573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325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213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6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085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68613-8197-8141-B953-0DB9F75F52F3}" type="datetimeFigureOut">
              <a:rPr lang="en-US" smtClean="0"/>
              <a:t>03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A47AF-83F0-244C-933E-86E9682B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728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6476" y="253061"/>
            <a:ext cx="5902597" cy="631056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74114" y="734741"/>
            <a:ext cx="2220327" cy="5339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smtClean="0"/>
              <a:t>S3 </a:t>
            </a:r>
            <a:r>
              <a:rPr lang="en-US" sz="1100" b="1" smtClean="0"/>
              <a:t>Fig.</a:t>
            </a:r>
            <a:r>
              <a:rPr lang="en-US" sz="1100" smtClean="0"/>
              <a:t> </a:t>
            </a:r>
            <a:r>
              <a:rPr lang="en-US" sz="1100" b="1" dirty="0"/>
              <a:t>Functional categorization of the </a:t>
            </a:r>
            <a:r>
              <a:rPr lang="en-US" sz="1100" b="1" dirty="0" err="1"/>
              <a:t>unigenes</a:t>
            </a:r>
            <a:r>
              <a:rPr lang="en-US" sz="1100" dirty="0"/>
              <a:t>. The </a:t>
            </a:r>
            <a:r>
              <a:rPr lang="en-US" sz="1100" dirty="0" err="1"/>
              <a:t>unigenes</a:t>
            </a:r>
            <a:r>
              <a:rPr lang="en-US" sz="1100" dirty="0"/>
              <a:t> overexpressed in the superior (37) and inferior (79) </a:t>
            </a:r>
            <a:r>
              <a:rPr lang="en-US" sz="1100" dirty="0" err="1"/>
              <a:t>spikelets</a:t>
            </a:r>
            <a:r>
              <a:rPr lang="en-US" sz="1100" dirty="0"/>
              <a:t> were grouped into 21 functional sub-categories (A-U) under six main functional categories: Metabolism (sub-categories A-C), Information Pathways (sub-categories D-I), Transport (sub-category J), Perception and Response to Stimuli (sub-categories K-N), Developmental Processes (sub-categories O-S) and Localization (sub-category T-U). Experimentally uncharacterized proteins were classified into sub-categories V (representing unclassified/unnamed proteins) and W (representing proteins with no match in the </a:t>
            </a:r>
            <a:r>
              <a:rPr lang="en-US" sz="1100" i="1" dirty="0"/>
              <a:t>Arabidopsis</a:t>
            </a:r>
            <a:r>
              <a:rPr lang="en-US" sz="1100" dirty="0"/>
              <a:t> database). The percentage of total </a:t>
            </a:r>
            <a:r>
              <a:rPr lang="en-US" sz="1100" dirty="0" err="1"/>
              <a:t>unigenes</a:t>
            </a:r>
            <a:r>
              <a:rPr lang="en-US" sz="1100" dirty="0"/>
              <a:t> in the AFL and BRL contributing to a specific sub-category is provided alongside the sub-category. The EST redundancy (in %) in each sub-category, which was calculated as the percentage of the number of ESTs representing the group divided by total number of ESTs, is also given for the AFL and BRL. </a:t>
            </a:r>
            <a:r>
              <a:rPr lang="en-US" sz="1100" b="1" dirty="0" smtClean="0"/>
              <a:t>.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3945775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207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rendra Prasad Shaw</dc:creator>
  <cp:lastModifiedBy>Birendra Prasad Shaw</cp:lastModifiedBy>
  <cp:revision>10</cp:revision>
  <dcterms:created xsi:type="dcterms:W3CDTF">2015-09-22T11:24:00Z</dcterms:created>
  <dcterms:modified xsi:type="dcterms:W3CDTF">2015-10-03T11:53:24Z</dcterms:modified>
</cp:coreProperties>
</file>